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8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08054E-7626-47DB-997F-8601B42771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409DBCD-FB80-4998-8D1D-F4B8631F3A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EB9AEE-44E5-4914-A43F-A025897F7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114D42-5C70-4A48-A492-E92A14422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A5A051-C20C-48F8-9FC0-069B638653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4517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E8140E-7728-4612-8B6B-B9088D8B1C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8A5F6C-8C29-4876-80BF-42E7B7F6E4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2A9AD4-7950-45FB-B03C-7F882879A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4137DB-BAEC-4DA6-9228-45B1F33A9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16E3D4-5C97-41D9-9566-2CB67E365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202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3716E16-B05D-4333-9166-AF1DB734B6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869020-C37C-46FF-AD73-BD0F1FCCCF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34BE7E-02D2-40F6-8545-D268EEE46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C6FBEB-2A54-412F-9135-EBE87ABD5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E6235E-7C99-4EEF-995E-22D8CC9E2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26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04836E-F955-4213-94AB-F64F92621A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47997A-4814-424B-AEE8-77562AF64F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1E499B-3B32-4059-B668-410C1E7C7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51C33D-8CC0-46CC-83F0-6FD81DF50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E0CAFA-CCA6-49E1-945B-40113DDF5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786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AFA220-81F9-4C0D-8387-141F4CC934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1D08CA-D0A4-4E3B-8D6C-9B2FF31EDB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9EF1B3-7A8A-413E-ACBB-8F4C9ACFE9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B184F9-F103-47CE-928D-A7297B502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AB3F3A-8761-423F-B42E-FFA29A9D8E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076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D387C8-81FB-420F-94EB-0717AF3D89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8C2F1E-B176-4CD2-B7A3-B37D426B8F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D0D312-4F1C-4908-BF43-CD2C060EE3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0498D3-275A-4A73-B4D9-F32A3E15D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284A5A-1AB4-4E5B-B643-C953056B1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B32908-B3BB-423F-8EE8-0F9444D392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239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EB8E3A-CD4F-4731-82B4-C87EC86603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0061EC-9694-4327-9E0A-BD101F5B66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11EC05-D41B-417B-8C69-27ED7659D4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C914A2-FB73-4187-A788-8A5D39BB2A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D8BA48-FE2E-4F45-BC7D-392F2E41B3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714A08-5BE3-4DE6-8621-F91E60162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257795-B07B-48C5-98D5-54CD33EC5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86A899E-EEFB-4F78-A88A-EEA6C2D90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89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5A0166-8791-45B5-95E0-C9D245B4B4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B2F23FF-C4B7-4925-9C9E-DC7B03441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94CAEB-9D6F-4DDE-BA10-11F9BC418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15ECB29-76CD-47BF-BA05-DBA6FDA5F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005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72D3B8-FFA8-4A0D-87F7-68C9BB039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8B2B57-2040-4388-B4A9-624D2669E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4DB932E-E22E-4E95-89B7-2AA1D1D84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236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CAE07D-F6FE-4A20-8D54-30026E70A6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7693E4-0E3E-46DF-8735-C89EF688A0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B25B8B-DC90-466F-8854-F1F09588D4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3BD0C4-BA0D-48A4-8F9A-5AEE7DC5D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862527-596D-441A-AD48-95235158B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F4635C-882E-4C01-BD67-7CBDF3819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731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D0DD6-8199-49C4-B0E7-D1DFE104F0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172C74A-0E38-425E-A883-40A4E0CFB7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DA250E-C6E4-45DF-BA2C-B94AFF1390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393888-453C-4732-9AAF-F7F073F0C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BB9404-99F3-4EFF-A996-54C2FFA9A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B082B1-1966-4809-9E71-E2B4935CE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386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B1DB41F-CC05-43C0-8F57-B8DB393726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ABAAE1-BAD7-4077-83C7-24FB68CB14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156B5B-6D9F-4195-93A4-9232F9B302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055BC-C00A-42B6-B7C0-5576C5C4F36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B9DFD9-2E4D-42EF-AC2E-ACA0247909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66425B-5B8C-4EAD-BF02-E82E6CF0D3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C09620-CEA0-4C6E-91AE-BE5DFCE60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437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28" t="21133" r="33927" b="44642"/>
          <a:stretch/>
        </p:blipFill>
        <p:spPr>
          <a:xfrm>
            <a:off x="1828800" y="2527661"/>
            <a:ext cx="5709744" cy="4100287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7082348" y="774654"/>
            <a:ext cx="4804852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CR for KRAS cDNA 454 library</a:t>
            </a:r>
          </a:p>
          <a:p>
            <a:r>
              <a:rPr lang="en-US" sz="1400" dirty="0"/>
              <a:t>Wt – primers target wild type (wt) KRAS</a:t>
            </a:r>
          </a:p>
          <a:p>
            <a:r>
              <a:rPr lang="en-US" sz="1400" dirty="0"/>
              <a:t>Mutant – primers target mutant observed in </a:t>
            </a:r>
            <a:r>
              <a:rPr lang="en-US" sz="1400" dirty="0" err="1"/>
              <a:t>CAsE</a:t>
            </a:r>
            <a:r>
              <a:rPr lang="en-US" sz="1400" dirty="0"/>
              <a:t>-PE</a:t>
            </a:r>
          </a:p>
          <a:p>
            <a:r>
              <a:rPr lang="en-US" sz="1400" dirty="0"/>
              <a:t>Prostate = RNA (isolated from FF Caucasian epithelial explant)</a:t>
            </a:r>
          </a:p>
          <a:p>
            <a:r>
              <a:rPr lang="en-US" sz="1400" dirty="0" err="1"/>
              <a:t>CAsE</a:t>
            </a:r>
            <a:r>
              <a:rPr lang="en-US" sz="1400" dirty="0"/>
              <a:t>-PE = RNA isolated from transformed </a:t>
            </a:r>
            <a:r>
              <a:rPr lang="en-US" sz="1400" dirty="0" err="1"/>
              <a:t>CAsE</a:t>
            </a:r>
            <a:r>
              <a:rPr lang="en-US" sz="1400" dirty="0"/>
              <a:t>-PE cells</a:t>
            </a:r>
          </a:p>
          <a:p>
            <a:r>
              <a:rPr lang="en-US" sz="1400" dirty="0"/>
              <a:t>RWPE-1 = RNA isolated from RWPE-1 prostate epithelia</a:t>
            </a:r>
          </a:p>
          <a:p>
            <a:r>
              <a:rPr lang="en-US" sz="1400" dirty="0"/>
              <a:t>No Template = no PCR template control</a:t>
            </a:r>
          </a:p>
        </p:txBody>
      </p:sp>
      <p:sp>
        <p:nvSpPr>
          <p:cNvPr id="4" name="TextBox 3"/>
          <p:cNvSpPr txBox="1"/>
          <p:nvPr/>
        </p:nvSpPr>
        <p:spPr>
          <a:xfrm rot="16200000">
            <a:off x="1594366" y="1753752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W Stds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2213629" y="1731693"/>
            <a:ext cx="1098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state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2822486" y="1799494"/>
            <a:ext cx="1003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AsE-PE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3352787" y="1779820"/>
            <a:ext cx="1003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WPE-1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3957114" y="1714495"/>
            <a:ext cx="1098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state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4565971" y="1782296"/>
            <a:ext cx="1003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AsE-PE</a:t>
            </a:r>
          </a:p>
        </p:txBody>
      </p:sp>
      <p:sp>
        <p:nvSpPr>
          <p:cNvPr id="15" name="TextBox 14"/>
          <p:cNvSpPr txBox="1"/>
          <p:nvPr/>
        </p:nvSpPr>
        <p:spPr>
          <a:xfrm rot="16200000">
            <a:off x="5096272" y="1762622"/>
            <a:ext cx="1003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WPE-1</a:t>
            </a:r>
          </a:p>
        </p:txBody>
      </p:sp>
      <p:sp>
        <p:nvSpPr>
          <p:cNvPr id="18" name="Left Bracket 17"/>
          <p:cNvSpPr/>
          <p:nvPr/>
        </p:nvSpPr>
        <p:spPr>
          <a:xfrm rot="5400000">
            <a:off x="3297837" y="764352"/>
            <a:ext cx="84677" cy="1397942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Left Bracket 18"/>
          <p:cNvSpPr/>
          <p:nvPr/>
        </p:nvSpPr>
        <p:spPr>
          <a:xfrm rot="5400000">
            <a:off x="5025327" y="770688"/>
            <a:ext cx="84677" cy="1397942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2768674" y="754603"/>
            <a:ext cx="1143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 KRAS primers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487232" y="774654"/>
            <a:ext cx="1143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t KRAS primer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389E07B-AE69-48B1-B051-210E71823DE5}"/>
              </a:ext>
            </a:extLst>
          </p:cNvPr>
          <p:cNvSpPr txBox="1"/>
          <p:nvPr/>
        </p:nvSpPr>
        <p:spPr>
          <a:xfrm rot="16200000">
            <a:off x="5406536" y="1487173"/>
            <a:ext cx="1590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o Templat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1C37D7A-458A-40F9-AD46-BAF7C9C73147}"/>
              </a:ext>
            </a:extLst>
          </p:cNvPr>
          <p:cNvSpPr txBox="1"/>
          <p:nvPr/>
        </p:nvSpPr>
        <p:spPr>
          <a:xfrm>
            <a:off x="815314" y="282405"/>
            <a:ext cx="9629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5 Fig</a:t>
            </a:r>
            <a:r>
              <a:rPr lang="en-US" b="1"/>
              <a:t>. </a:t>
            </a:r>
            <a:r>
              <a:rPr lang="en-US"/>
              <a:t>cDNA </a:t>
            </a:r>
            <a:r>
              <a:rPr lang="en-US" dirty="0"/>
              <a:t>KRAS amplicons for 454 sequencing using </a:t>
            </a:r>
            <a:r>
              <a:rPr lang="en-US" dirty="0" err="1"/>
              <a:t>wt</a:t>
            </a:r>
            <a:r>
              <a:rPr lang="en-US" dirty="0"/>
              <a:t> and </a:t>
            </a:r>
            <a:r>
              <a:rPr lang="en-US" dirty="0" err="1"/>
              <a:t>mt</a:t>
            </a:r>
            <a:r>
              <a:rPr lang="en-US" dirty="0"/>
              <a:t> specific prime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C413BBC-B981-4876-ABAC-08E2F3244935}"/>
              </a:ext>
            </a:extLst>
          </p:cNvPr>
          <p:cNvSpPr txBox="1"/>
          <p:nvPr/>
        </p:nvSpPr>
        <p:spPr>
          <a:xfrm rot="16200000">
            <a:off x="6174936" y="1693733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W Std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32B575F-3A88-419F-A053-31AD5FF427D0}"/>
              </a:ext>
            </a:extLst>
          </p:cNvPr>
          <p:cNvSpPr txBox="1"/>
          <p:nvPr/>
        </p:nvSpPr>
        <p:spPr>
          <a:xfrm>
            <a:off x="7925640" y="2373772"/>
            <a:ext cx="18374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(FF = fresh frozen)</a:t>
            </a:r>
          </a:p>
        </p:txBody>
      </p:sp>
    </p:spTree>
    <p:extLst>
      <p:ext uri="{BB962C8B-B14F-4D97-AF65-F5344CB8AC3E}">
        <p14:creationId xmlns:p14="http://schemas.microsoft.com/office/powerpoint/2010/main" val="2737777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97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rick, Alex (NIH/NIEHS) [E]</dc:creator>
  <cp:lastModifiedBy>Merrick, Alex (NIH/NIEHS) [E]</cp:lastModifiedBy>
  <cp:revision>7</cp:revision>
  <dcterms:created xsi:type="dcterms:W3CDTF">2018-09-14T16:00:52Z</dcterms:created>
  <dcterms:modified xsi:type="dcterms:W3CDTF">2019-02-07T15:45:48Z</dcterms:modified>
</cp:coreProperties>
</file>